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F2F0B6-4436-FF68-203C-F2EC23A51E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BA067D-C507-88DB-D160-87C88F5CA3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45E0F7-2A3A-B2DC-CD33-9EB3D627C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2FB6D8-5C4C-4417-6673-DCC14AC90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9019DA-9681-8C47-1622-59D4640282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22941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A149C1-50C7-28CB-61E0-E94F26310B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FE7CDA-C59B-E3A7-2216-6FF8BAEECE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3DF586-FFC7-020E-AE53-2276861F8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F74884-4B85-0D1E-5183-0D9BC2F17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6A5808-CA0D-FA2A-2AEB-7E9519CC8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60330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6D6D64-79E9-3652-5E09-F876FF5B2C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FA27E6-7FF8-0028-F581-E4C029E9A5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2AB12E-8A9B-F16A-A476-41C4F7B8E1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DE1764-DBFC-51CD-3736-20F0BF7F4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1A1583-828B-53FE-DC21-7391C35C2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11806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66E72D-7E39-1933-8B0E-05A512BB00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BD30D8-0D42-14A4-AC2E-2011EC76F1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C8025E-2DDF-B05A-4381-94A17E00C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A8F105-D700-F111-15F0-BC3014F73C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CA6E36-16C1-D7A3-BF6E-F03CE636F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10408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4FC7D5-F2E1-7571-52F0-4545EEF5A6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6C8DAE-464F-1019-B5CB-C42F975CA1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D669F2-432C-678F-A9BD-B4A43C17D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8756BE-272D-9F6B-3A69-5549FBB14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B90B23-D30C-4093-F445-E13F206CA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0273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45557-2F1F-C3F2-043C-74CDBFBB08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8CD3EA-9E39-4356-EE8F-8AC152875C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CE3AC1-346E-BED5-2DD1-09400A4054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9DC1E0-9E6F-E637-F563-77CB6137D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F74447-09F8-693D-145D-C3AD0D5B7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514ED1-7CEA-92B4-47FA-5A5077644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86294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D98F0D-5ABA-1AA1-CAB8-0B6B30BC07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9D85F5-918F-E123-7975-A8843D2770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4DD104-8A2E-EAA0-657D-DB34E6285C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6EFAF8-B14E-69D9-3A39-E9B480C5C6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1B7916-2186-EA23-D91F-045B4C88F1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8B0D86-D12A-E5DF-4500-7C2EA2496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EE8F18-DA99-921A-BB69-0C042F3E4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B23184F-4E96-999F-7D9D-B6D2433BB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66553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E24EA6-B6AB-D79A-C755-1B03B77322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E239E7-2821-191C-2C68-4AC34A75A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49BB965-E970-88C0-B9E4-F6DD8A5C1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0D3FF37-091E-FAF3-EE6B-45C36F104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23706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475C20-9F7C-0859-FFE5-CACB94B37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A72A7A-C8FD-6043-9B0C-D611E76AE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58F0F9-2635-C81B-ECFE-7B9602923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5269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A7E238-EE6B-1217-AD48-8498E1ECF4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69AC5A-25AC-FBCE-2799-3C0D0957D6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1CFF03-4A96-EE9A-02BC-043D748EEA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734041-16FD-8C5D-0C80-462F42017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C16E67-D9DE-EF62-6A37-33E94AB3F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C8EBC3-1EA3-1931-5DF1-4DC7F1B5DE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889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9D164F-5A33-BF99-FD0B-08BC7830EA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E950944-B518-A143-3190-3C30827C30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BD6F46-AF20-FE2F-5326-EC73587174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9A35F7-E434-DFF5-D141-061EBCC40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CDB945-C8EA-C62A-469E-0831B2C69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B234E2-760F-8EF6-2ACC-8C770E3C3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95254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FC7F43C-EA49-23E4-A289-68EEE8AEE5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C250E8-538A-83BC-C082-BCE45AED04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A65DCE-4E94-5B3E-6B54-9614D3316C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D3F99-E5C9-4ABE-9CCC-30A37306B80E}" type="datetimeFigureOut">
              <a:rPr lang="en-IN" smtClean="0"/>
              <a:t>01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E202B1-463D-3AD4-BBC1-80175C8D95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6F9A73-B34D-CE93-1B5B-AF76B0EFD0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E7B5C7-A01B-4E46-A23C-5DCE42294E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5272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EA07D3B-979A-6AA0-CEC1-8F7012F4FB8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591" t="49897" r="26890" b="12440"/>
          <a:stretch/>
        </p:blipFill>
        <p:spPr>
          <a:xfrm>
            <a:off x="3770722" y="2460396"/>
            <a:ext cx="4506013" cy="258294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436C44D-6C65-3F66-DECA-DFF04BCCFA8F}"/>
              </a:ext>
            </a:extLst>
          </p:cNvPr>
          <p:cNvSpPr/>
          <p:nvPr/>
        </p:nvSpPr>
        <p:spPr>
          <a:xfrm>
            <a:off x="4072379" y="2686639"/>
            <a:ext cx="2686640" cy="9426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5ECCF3F-F683-ECC7-1E81-12717230619A}"/>
              </a:ext>
            </a:extLst>
          </p:cNvPr>
          <p:cNvSpPr/>
          <p:nvPr/>
        </p:nvSpPr>
        <p:spPr>
          <a:xfrm>
            <a:off x="4083375" y="3894842"/>
            <a:ext cx="2686640" cy="9426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ECD3461-7632-C6E6-B0D9-AFEE63281957}"/>
              </a:ext>
            </a:extLst>
          </p:cNvPr>
          <p:cNvSpPr txBox="1"/>
          <p:nvPr/>
        </p:nvSpPr>
        <p:spPr>
          <a:xfrm>
            <a:off x="3271102" y="3082563"/>
            <a:ext cx="989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50</a:t>
            </a:r>
            <a:endParaRPr lang="en-IN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5B66E73-0599-F49E-6443-3B82BE3182B2}"/>
              </a:ext>
            </a:extLst>
          </p:cNvPr>
          <p:cNvSpPr txBox="1"/>
          <p:nvPr/>
        </p:nvSpPr>
        <p:spPr>
          <a:xfrm>
            <a:off x="3272671" y="4132199"/>
            <a:ext cx="989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50</a:t>
            </a:r>
            <a:endParaRPr lang="en-IN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9AF08F5-0B06-AF3B-B8F9-46A0D54E68EA}"/>
              </a:ext>
            </a:extLst>
          </p:cNvPr>
          <p:cNvSpPr txBox="1"/>
          <p:nvPr/>
        </p:nvSpPr>
        <p:spPr>
          <a:xfrm>
            <a:off x="3271101" y="2277300"/>
            <a:ext cx="989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KDa</a:t>
            </a:r>
            <a:endParaRPr lang="en-IN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DADB65F-3AA5-7387-774D-E778DF315E99}"/>
              </a:ext>
            </a:extLst>
          </p:cNvPr>
          <p:cNvSpPr txBox="1"/>
          <p:nvPr/>
        </p:nvSpPr>
        <p:spPr>
          <a:xfrm>
            <a:off x="4194928" y="2055043"/>
            <a:ext cx="35444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 1       2          3        4           5       6</a:t>
            </a:r>
            <a:endParaRPr lang="en-IN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041F5E5-281A-B5AC-3A8B-7085FD74998C}"/>
              </a:ext>
            </a:extLst>
          </p:cNvPr>
          <p:cNvSpPr txBox="1"/>
          <p:nvPr/>
        </p:nvSpPr>
        <p:spPr>
          <a:xfrm>
            <a:off x="7975075" y="2960016"/>
            <a:ext cx="1253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Symbol" panose="05050102010706020507" pitchFamily="18" charset="2"/>
              </a:rPr>
              <a:t>a</a:t>
            </a:r>
            <a:r>
              <a:rPr lang="en-US" dirty="0">
                <a:solidFill>
                  <a:srgbClr val="FF0000"/>
                </a:solidFill>
              </a:rPr>
              <a:t>-Tubulin</a:t>
            </a:r>
            <a:endParaRPr lang="en-IN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E37AE63-ED1E-852F-808C-A4B0F83F8FB4}"/>
              </a:ext>
            </a:extLst>
          </p:cNvPr>
          <p:cNvSpPr txBox="1"/>
          <p:nvPr/>
        </p:nvSpPr>
        <p:spPr>
          <a:xfrm>
            <a:off x="7962505" y="4132199"/>
            <a:ext cx="1253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Symbol" panose="05050102010706020507" pitchFamily="18" charset="2"/>
              </a:rPr>
              <a:t>a</a:t>
            </a:r>
            <a:r>
              <a:rPr lang="en-US" dirty="0">
                <a:solidFill>
                  <a:srgbClr val="FF0000"/>
                </a:solidFill>
              </a:rPr>
              <a:t>-Tubulin</a:t>
            </a:r>
            <a:endParaRPr lang="en-IN" dirty="0">
              <a:solidFill>
                <a:srgbClr val="FF0000"/>
              </a:solidFill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76DC2724-A759-15CD-1D77-755C4CD4879D}"/>
              </a:ext>
            </a:extLst>
          </p:cNvPr>
          <p:cNvCxnSpPr/>
          <p:nvPr/>
        </p:nvCxnSpPr>
        <p:spPr>
          <a:xfrm>
            <a:off x="3054285" y="2646632"/>
            <a:ext cx="0" cy="87899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4D0768E4-D412-A48E-054D-99F4F1749E80}"/>
              </a:ext>
            </a:extLst>
          </p:cNvPr>
          <p:cNvCxnSpPr/>
          <p:nvPr/>
        </p:nvCxnSpPr>
        <p:spPr>
          <a:xfrm>
            <a:off x="3054285" y="3894842"/>
            <a:ext cx="0" cy="87899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F4644AE1-FBC1-1731-21DB-34BB375295CA}"/>
              </a:ext>
            </a:extLst>
          </p:cNvPr>
          <p:cNvSpPr txBox="1"/>
          <p:nvPr/>
        </p:nvSpPr>
        <p:spPr>
          <a:xfrm>
            <a:off x="981955" y="2884602"/>
            <a:ext cx="1761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ermal Lysate</a:t>
            </a:r>
            <a:endParaRPr lang="en-IN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8A125FB-8611-DEEF-F9CF-5063A0F2A987}"/>
              </a:ext>
            </a:extLst>
          </p:cNvPr>
          <p:cNvSpPr txBox="1"/>
          <p:nvPr/>
        </p:nvSpPr>
        <p:spPr>
          <a:xfrm>
            <a:off x="961535" y="4132199"/>
            <a:ext cx="17612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pidermal Lysate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865350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84542FA-47E7-7D9E-474A-44A3B7B722C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183" t="39449" r="23375" b="23025"/>
          <a:stretch/>
        </p:blipFill>
        <p:spPr>
          <a:xfrm>
            <a:off x="3789576" y="2493892"/>
            <a:ext cx="4590854" cy="2785119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DE775DB4-5C41-DE41-3D91-68E59E25CD1B}"/>
              </a:ext>
            </a:extLst>
          </p:cNvPr>
          <p:cNvSpPr/>
          <p:nvPr/>
        </p:nvSpPr>
        <p:spPr>
          <a:xfrm>
            <a:off x="4279772" y="2969440"/>
            <a:ext cx="2686640" cy="9426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85B41F3-A453-2AE6-1A43-B6F0AFE1A701}"/>
              </a:ext>
            </a:extLst>
          </p:cNvPr>
          <p:cNvSpPr/>
          <p:nvPr/>
        </p:nvSpPr>
        <p:spPr>
          <a:xfrm>
            <a:off x="4290768" y="4036242"/>
            <a:ext cx="2686640" cy="9426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A223868-84DF-C68B-8FA1-57D474DA330D}"/>
              </a:ext>
            </a:extLst>
          </p:cNvPr>
          <p:cNvSpPr txBox="1"/>
          <p:nvPr/>
        </p:nvSpPr>
        <p:spPr>
          <a:xfrm>
            <a:off x="3478495" y="3591610"/>
            <a:ext cx="989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100</a:t>
            </a:r>
            <a:endParaRPr lang="en-IN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76DF947-71B1-F14E-9B5A-5260CE7331B7}"/>
              </a:ext>
            </a:extLst>
          </p:cNvPr>
          <p:cNvSpPr txBox="1"/>
          <p:nvPr/>
        </p:nvSpPr>
        <p:spPr>
          <a:xfrm>
            <a:off x="3480064" y="4641248"/>
            <a:ext cx="989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100</a:t>
            </a:r>
            <a:endParaRPr lang="en-IN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432A1C6-5CAC-FDDF-4399-DA784EE31B06}"/>
              </a:ext>
            </a:extLst>
          </p:cNvPr>
          <p:cNvSpPr txBox="1"/>
          <p:nvPr/>
        </p:nvSpPr>
        <p:spPr>
          <a:xfrm>
            <a:off x="3478494" y="2767493"/>
            <a:ext cx="989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KDa</a:t>
            </a:r>
            <a:endParaRPr lang="en-IN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BAD5525-2AE3-13C5-F11A-272B0F6DE9F7}"/>
              </a:ext>
            </a:extLst>
          </p:cNvPr>
          <p:cNvSpPr txBox="1"/>
          <p:nvPr/>
        </p:nvSpPr>
        <p:spPr>
          <a:xfrm>
            <a:off x="4402321" y="2545236"/>
            <a:ext cx="35444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 1       2          3        4           5       6</a:t>
            </a:r>
            <a:endParaRPr lang="en-IN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306FD1C-8B8E-33E9-86DE-37030796102F}"/>
              </a:ext>
            </a:extLst>
          </p:cNvPr>
          <p:cNvSpPr txBox="1"/>
          <p:nvPr/>
        </p:nvSpPr>
        <p:spPr>
          <a:xfrm>
            <a:off x="7946799" y="3523932"/>
            <a:ext cx="1253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Symbol" panose="05050102010706020507" pitchFamily="18" charset="2"/>
              </a:rPr>
              <a:t>HK2</a:t>
            </a:r>
            <a:endParaRPr lang="en-IN" dirty="0">
              <a:solidFill>
                <a:srgbClr val="FF0000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5A373F3-39B9-40C7-8B31-C3B9F2F6EF0A}"/>
              </a:ext>
            </a:extLst>
          </p:cNvPr>
          <p:cNvSpPr txBox="1"/>
          <p:nvPr/>
        </p:nvSpPr>
        <p:spPr>
          <a:xfrm>
            <a:off x="7946799" y="4455199"/>
            <a:ext cx="1253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Symbol" panose="05050102010706020507" pitchFamily="18" charset="2"/>
              </a:rPr>
              <a:t>HK2</a:t>
            </a:r>
            <a:endParaRPr lang="en-IN" dirty="0">
              <a:solidFill>
                <a:srgbClr val="FF0000"/>
              </a:solidFill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66545004-BD18-8E25-C75A-5B3BC1E910CF}"/>
              </a:ext>
            </a:extLst>
          </p:cNvPr>
          <p:cNvCxnSpPr/>
          <p:nvPr/>
        </p:nvCxnSpPr>
        <p:spPr>
          <a:xfrm>
            <a:off x="3261678" y="2967141"/>
            <a:ext cx="0" cy="87899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129F9D41-2A84-E7B1-86BE-4A4C604DB11E}"/>
              </a:ext>
            </a:extLst>
          </p:cNvPr>
          <p:cNvCxnSpPr/>
          <p:nvPr/>
        </p:nvCxnSpPr>
        <p:spPr>
          <a:xfrm>
            <a:off x="3261678" y="4102229"/>
            <a:ext cx="0" cy="87899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A8A26967-908E-1BC4-B04F-F5C84BA8D030}"/>
              </a:ext>
            </a:extLst>
          </p:cNvPr>
          <p:cNvSpPr txBox="1"/>
          <p:nvPr/>
        </p:nvSpPr>
        <p:spPr>
          <a:xfrm>
            <a:off x="1189348" y="3205111"/>
            <a:ext cx="1761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pidermal Lysate</a:t>
            </a:r>
            <a:endParaRPr lang="en-IN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03959-780B-851C-E80D-AD55CB973516}"/>
              </a:ext>
            </a:extLst>
          </p:cNvPr>
          <p:cNvSpPr txBox="1"/>
          <p:nvPr/>
        </p:nvSpPr>
        <p:spPr>
          <a:xfrm>
            <a:off x="1334681" y="4455199"/>
            <a:ext cx="17612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ermal Lysate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024450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2</Words>
  <Application>Microsoft Office PowerPoint</Application>
  <PresentationFormat>Widescreen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ttkarsh Ayyangar</dc:creator>
  <cp:lastModifiedBy>uttkarsh.ayyangar93@outlook.com</cp:lastModifiedBy>
  <cp:revision>1</cp:revision>
  <dcterms:created xsi:type="dcterms:W3CDTF">2024-01-01T17:29:14Z</dcterms:created>
  <dcterms:modified xsi:type="dcterms:W3CDTF">2024-01-01T17:41:08Z</dcterms:modified>
</cp:coreProperties>
</file>